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D547F-E544-496D-A1AA-EE1E72995C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5191C-504B-4652-8D2C-07D582F110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0DB6F-2559-4903-A6B1-A1A58A5494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7A7BE-E681-4735-B961-35C6A1D659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993AB-838A-4761-9241-AEC0823692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EEE28-EF82-4993-8482-8FA22A68A5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5705B-D39E-4CA2-8189-B3C7BE2BEB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042F6-328B-4C58-AB9C-51BA647AE5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3E985-DBF0-4920-B1D9-3FB1F64B36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EE1D8-0BA0-47EE-A295-E75D6A8592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763C8-8A22-48AE-8F44-C9FF293AE6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CC780-43E8-48C0-BEEB-FE53C1D43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2E88604-5A59-4AFD-9D79-BCA87529829B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D3BCC46-BC43-4215-A3DC-48514634B16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円/楕円 3"/>
          <p:cNvSpPr/>
          <p:nvPr/>
        </p:nvSpPr>
        <p:spPr>
          <a:xfrm>
            <a:off x="289080" y="3679920"/>
            <a:ext cx="4033800" cy="287964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1859c">
                  <a:alpha val="50196"/>
                </a:srgbClr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円/楕円 4"/>
          <p:cNvSpPr/>
          <p:nvPr/>
        </p:nvSpPr>
        <p:spPr>
          <a:xfrm>
            <a:off x="1390680" y="3984480"/>
            <a:ext cx="2928960" cy="229248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>
                  <a:alpha val="50196"/>
                </a:srgbClr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2140200" y="489276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6"/>
          <p:cNvSpPr/>
          <p:nvPr/>
        </p:nvSpPr>
        <p:spPr>
          <a:xfrm>
            <a:off x="975600" y="590724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4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701640" y="413712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61.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正方形/長方形 8"/>
          <p:cNvSpPr/>
          <p:nvPr/>
        </p:nvSpPr>
        <p:spPr>
          <a:xfrm>
            <a:off x="2908440" y="4659480"/>
            <a:ext cx="1230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 2SD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hI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正方形/長方形 9"/>
          <p:cNvSpPr/>
          <p:nvPr/>
        </p:nvSpPr>
        <p:spPr>
          <a:xfrm>
            <a:off x="233280" y="4778280"/>
            <a:ext cx="1098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 2S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円/楕円 10"/>
          <p:cNvSpPr/>
          <p:nvPr/>
        </p:nvSpPr>
        <p:spPr>
          <a:xfrm>
            <a:off x="4878360" y="3697200"/>
            <a:ext cx="4035600" cy="287964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1859c">
                  <a:alpha val="50196"/>
                </a:srgbClr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円/楕円 11"/>
          <p:cNvSpPr/>
          <p:nvPr/>
        </p:nvSpPr>
        <p:spPr>
          <a:xfrm>
            <a:off x="4878360" y="3984480"/>
            <a:ext cx="2928960" cy="229248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>
                  <a:alpha val="50196"/>
                </a:srgbClr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正方形/長方形 12"/>
          <p:cNvSpPr/>
          <p:nvPr/>
        </p:nvSpPr>
        <p:spPr>
          <a:xfrm>
            <a:off x="5032440" y="4570560"/>
            <a:ext cx="12301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 2SD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q-value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hI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正方形/長方形 13"/>
          <p:cNvSpPr/>
          <p:nvPr/>
        </p:nvSpPr>
        <p:spPr>
          <a:xfrm>
            <a:off x="7807320" y="4659480"/>
            <a:ext cx="11462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SD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q-valu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4"/>
          <p:cNvSpPr/>
          <p:nvPr/>
        </p:nvSpPr>
        <p:spPr>
          <a:xfrm>
            <a:off x="6775560" y="489276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5"/>
          <p:cNvSpPr/>
          <p:nvPr/>
        </p:nvSpPr>
        <p:spPr>
          <a:xfrm>
            <a:off x="7810560" y="587520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6"/>
          <p:cNvSpPr/>
          <p:nvPr/>
        </p:nvSpPr>
        <p:spPr>
          <a:xfrm>
            <a:off x="7638480" y="4137120"/>
            <a:ext cx="9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58.82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円/楕円 17"/>
          <p:cNvSpPr/>
          <p:nvPr/>
        </p:nvSpPr>
        <p:spPr>
          <a:xfrm>
            <a:off x="1325520" y="577800"/>
            <a:ext cx="6537240" cy="310032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1859c">
                  <a:alpha val="50196"/>
                </a:srgbClr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円/楕円 18"/>
          <p:cNvSpPr/>
          <p:nvPr/>
        </p:nvSpPr>
        <p:spPr>
          <a:xfrm>
            <a:off x="1871640" y="735120"/>
            <a:ext cx="4192560" cy="288108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1859c">
                  <a:alpha val="30196"/>
                </a:srgbClr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円/楕円 19"/>
          <p:cNvSpPr/>
          <p:nvPr/>
        </p:nvSpPr>
        <p:spPr>
          <a:xfrm>
            <a:off x="3206880" y="735120"/>
            <a:ext cx="3857400" cy="288108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1859c">
                  <a:alpha val="30196"/>
                </a:srgbClr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正方形/長方形 20"/>
          <p:cNvSpPr/>
          <p:nvPr/>
        </p:nvSpPr>
        <p:spPr>
          <a:xfrm>
            <a:off x="2019240" y="1847880"/>
            <a:ext cx="1106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q-valu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正方形/長方形 21"/>
          <p:cNvSpPr/>
          <p:nvPr/>
        </p:nvSpPr>
        <p:spPr>
          <a:xfrm>
            <a:off x="5985000" y="1847880"/>
            <a:ext cx="1176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 2SD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22"/>
          <p:cNvSpPr/>
          <p:nvPr/>
        </p:nvSpPr>
        <p:spPr>
          <a:xfrm>
            <a:off x="4068360" y="468360"/>
            <a:ext cx="86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正方形/長方形 23"/>
          <p:cNvSpPr/>
          <p:nvPr/>
        </p:nvSpPr>
        <p:spPr>
          <a:xfrm>
            <a:off x="6912720" y="1630440"/>
            <a:ext cx="101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65(265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4"/>
          <p:cNvSpPr/>
          <p:nvPr/>
        </p:nvSpPr>
        <p:spPr>
          <a:xfrm>
            <a:off x="5653800" y="2824200"/>
            <a:ext cx="101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06(297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正方形/長方形 25"/>
          <p:cNvSpPr/>
          <p:nvPr/>
        </p:nvSpPr>
        <p:spPr>
          <a:xfrm>
            <a:off x="2349360" y="2824200"/>
            <a:ext cx="101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43(54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正方形/長方形 26"/>
          <p:cNvSpPr/>
          <p:nvPr/>
        </p:nvSpPr>
        <p:spPr>
          <a:xfrm>
            <a:off x="4138560" y="1630440"/>
            <a:ext cx="9698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&amp; 2SD &amp;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q-valu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7"/>
          <p:cNvSpPr/>
          <p:nvPr/>
        </p:nvSpPr>
        <p:spPr>
          <a:xfrm>
            <a:off x="4089240" y="2824200"/>
            <a:ext cx="101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48(57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8"/>
          <p:cNvSpPr/>
          <p:nvPr/>
        </p:nvSpPr>
        <p:spPr>
          <a:xfrm>
            <a:off x="77400" y="76320"/>
            <a:ext cx="2905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ヒラギノ角ゴ ProN"/>
              </a:rPr>
              <a:t>Additional data file 1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30"/>
          <p:cNvSpPr/>
          <p:nvPr/>
        </p:nvSpPr>
        <p:spPr>
          <a:xfrm>
            <a:off x="292680" y="735120"/>
            <a:ext cx="47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31"/>
          <p:cNvSpPr/>
          <p:nvPr/>
        </p:nvSpPr>
        <p:spPr>
          <a:xfrm>
            <a:off x="292680" y="3753000"/>
            <a:ext cx="47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32"/>
          <p:cNvSpPr/>
          <p:nvPr/>
        </p:nvSpPr>
        <p:spPr>
          <a:xfrm>
            <a:off x="4709160" y="3772080"/>
            <a:ext cx="47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グラフ 5" descr=""/>
          <p:cNvPicPr/>
          <p:nvPr/>
        </p:nvPicPr>
        <p:blipFill>
          <a:blip r:embed="rId1"/>
          <a:stretch/>
        </p:blipFill>
        <p:spPr>
          <a:xfrm>
            <a:off x="1835280" y="3676680"/>
            <a:ext cx="5424480" cy="2852640"/>
          </a:xfrm>
          <a:prstGeom prst="rect">
            <a:avLst/>
          </a:prstGeom>
          <a:ln w="0">
            <a:noFill/>
          </a:ln>
        </p:spPr>
      </p:pic>
      <p:pic>
        <p:nvPicPr>
          <p:cNvPr id="71" name="グラフ 6" descr=""/>
          <p:cNvPicPr/>
          <p:nvPr/>
        </p:nvPicPr>
        <p:blipFill>
          <a:blip r:embed="rId2"/>
          <a:stretch/>
        </p:blipFill>
        <p:spPr>
          <a:xfrm>
            <a:off x="1828800" y="341280"/>
            <a:ext cx="5419800" cy="2859120"/>
          </a:xfrm>
          <a:prstGeom prst="rect">
            <a:avLst/>
          </a:prstGeom>
          <a:ln w="0">
            <a:noFill/>
          </a:ln>
        </p:spPr>
      </p:pic>
      <p:sp>
        <p:nvSpPr>
          <p:cNvPr id="72" name="テキスト ボックス 30"/>
          <p:cNvSpPr/>
          <p:nvPr/>
        </p:nvSpPr>
        <p:spPr>
          <a:xfrm>
            <a:off x="292680" y="735120"/>
            <a:ext cx="47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6T23:00:30Z</dcterms:created>
  <dc:creator>外丸 靖浩</dc:creator>
  <dc:description/>
  <dc:language>en-US</dc:language>
  <cp:lastModifiedBy>外丸 靖浩</cp:lastModifiedBy>
  <cp:lastPrinted>2009-08-25T09:58:47Z</cp:lastPrinted>
  <dcterms:modified xsi:type="dcterms:W3CDTF">2009-10-23T09:02:16Z</dcterms:modified>
  <cp:revision>10</cp:revision>
  <dc:subject/>
  <dc:title>スライド 1</dc:title>
</cp:coreProperties>
</file>